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5" r:id="rId2"/>
  </p:sldIdLst>
  <p:sldSz cx="6119813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277" autoAdjust="0"/>
    <p:restoredTop sz="95530"/>
  </p:normalViewPr>
  <p:slideViewPr>
    <p:cSldViewPr snapToGrid="0" snapToObjects="1">
      <p:cViewPr varScale="1">
        <p:scale>
          <a:sx n="94" d="100"/>
          <a:sy n="94" d="100"/>
        </p:scale>
        <p:origin x="307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48BC63-E697-9840-9CDC-E8127E9CEE54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6800" y="1143000"/>
            <a:ext cx="2184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9A4545-7A69-1740-B017-8E7FE8B9630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022903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414125"/>
            <a:ext cx="5201841" cy="3008266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538401"/>
            <a:ext cx="4589860" cy="2086184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1F19-6D6B-6440-98D1-C4FA39DA160A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2619B-A855-634D-965E-60D5412CA25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78721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1F19-6D6B-6440-98D1-C4FA39DA160A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2619B-A855-634D-965E-60D5412CA25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45289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60041"/>
            <a:ext cx="1319585" cy="732264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60041"/>
            <a:ext cx="3882256" cy="732264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1F19-6D6B-6440-98D1-C4FA39DA160A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2619B-A855-634D-965E-60D5412CA25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63052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1F19-6D6B-6440-98D1-C4FA39DA160A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2619B-A855-634D-965E-60D5412CA25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6551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154193"/>
            <a:ext cx="5278339" cy="3594317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782513"/>
            <a:ext cx="5278339" cy="1890166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1F19-6D6B-6440-98D1-C4FA39DA160A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2619B-A855-634D-965E-60D5412CA25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35789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300203"/>
            <a:ext cx="2600921" cy="548248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300203"/>
            <a:ext cx="2600921" cy="548248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1F19-6D6B-6440-98D1-C4FA39DA160A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2619B-A855-634D-965E-60D5412CA25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911963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60043"/>
            <a:ext cx="5278339" cy="167014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2118188"/>
            <a:ext cx="2588967" cy="1038091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3156278"/>
            <a:ext cx="2588967" cy="464241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2118188"/>
            <a:ext cx="2601718" cy="1038091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3156278"/>
            <a:ext cx="2601718" cy="464241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1F19-6D6B-6440-98D1-C4FA39DA160A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2619B-A855-634D-965E-60D5412CA25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36177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1F19-6D6B-6440-98D1-C4FA39DA160A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2619B-A855-634D-965E-60D5412CA25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82298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1F19-6D6B-6440-98D1-C4FA39DA160A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2619B-A855-634D-965E-60D5412CA25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22330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76051"/>
            <a:ext cx="1973799" cy="2016178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244112"/>
            <a:ext cx="3098155" cy="6140542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592229"/>
            <a:ext cx="1973799" cy="480242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1F19-6D6B-6440-98D1-C4FA39DA160A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2619B-A855-634D-965E-60D5412CA25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79083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76051"/>
            <a:ext cx="1973799" cy="2016178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244112"/>
            <a:ext cx="3098155" cy="6140542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592229"/>
            <a:ext cx="1973799" cy="480242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1F19-6D6B-6440-98D1-C4FA39DA160A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2619B-A855-634D-965E-60D5412CA25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66322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60043"/>
            <a:ext cx="5278339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300203"/>
            <a:ext cx="5278339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8008709"/>
            <a:ext cx="1376958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B51F19-6D6B-6440-98D1-C4FA39DA160A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8008709"/>
            <a:ext cx="2065437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8008709"/>
            <a:ext cx="1376958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42619B-A855-634D-965E-60D5412CA25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135081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E32E358-A87D-763F-088A-3ABFFAC858AF}"/>
              </a:ext>
            </a:extLst>
          </p:cNvPr>
          <p:cNvSpPr txBox="1"/>
          <p:nvPr/>
        </p:nvSpPr>
        <p:spPr>
          <a:xfrm>
            <a:off x="1502885" y="3080583"/>
            <a:ext cx="3414982" cy="21544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kern="10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defRPr>
            </a:lvl1pPr>
          </a:lstStyle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</a:t>
            </a:r>
            <a:r>
              <a: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Serological </a:t>
            </a:r>
            <a:r>
              <a:rPr lang="en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 antibody assays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497601FB-9712-F5E7-C8A2-D0309760C84A}"/>
              </a:ext>
            </a:extLst>
          </p:cNvPr>
          <p:cNvSpPr txBox="1"/>
          <p:nvPr/>
        </p:nvSpPr>
        <p:spPr>
          <a:xfrm>
            <a:off x="324091" y="4467828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8765A01B-CD55-D693-B9BF-62BC5CB8CCF0}"/>
              </a:ext>
            </a:extLst>
          </p:cNvPr>
          <p:cNvSpPr txBox="1"/>
          <p:nvPr/>
        </p:nvSpPr>
        <p:spPr>
          <a:xfrm>
            <a:off x="393539" y="398169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zh-CN" altLang="en-US" dirty="0"/>
          </a:p>
        </p:txBody>
      </p:sp>
      <p:graphicFrame>
        <p:nvGraphicFramePr>
          <p:cNvPr id="10" name="表格 5">
            <a:extLst>
              <a:ext uri="{FF2B5EF4-FFF2-40B4-BE49-F238E27FC236}">
                <a16:creationId xmlns:a16="http://schemas.microsoft.com/office/drawing/2014/main" id="{4864F02D-F80B-D672-7E81-A2D4C103448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4726915"/>
              </p:ext>
            </p:extLst>
          </p:nvPr>
        </p:nvGraphicFramePr>
        <p:xfrm>
          <a:off x="176614" y="3296027"/>
          <a:ext cx="5726954" cy="4741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22189">
                  <a:extLst>
                    <a:ext uri="{9D8B030D-6E8A-4147-A177-3AD203B41FA5}">
                      <a16:colId xmlns:a16="http://schemas.microsoft.com/office/drawing/2014/main" val="1325240958"/>
                    </a:ext>
                  </a:extLst>
                </a:gridCol>
                <a:gridCol w="1143993">
                  <a:extLst>
                    <a:ext uri="{9D8B030D-6E8A-4147-A177-3AD203B41FA5}">
                      <a16:colId xmlns:a16="http://schemas.microsoft.com/office/drawing/2014/main" val="1965911417"/>
                    </a:ext>
                  </a:extLst>
                </a:gridCol>
                <a:gridCol w="1044892">
                  <a:extLst>
                    <a:ext uri="{9D8B030D-6E8A-4147-A177-3AD203B41FA5}">
                      <a16:colId xmlns:a16="http://schemas.microsoft.com/office/drawing/2014/main" val="1615177736"/>
                    </a:ext>
                  </a:extLst>
                </a:gridCol>
                <a:gridCol w="988828">
                  <a:extLst>
                    <a:ext uri="{9D8B030D-6E8A-4147-A177-3AD203B41FA5}">
                      <a16:colId xmlns:a16="http://schemas.microsoft.com/office/drawing/2014/main" val="1525542642"/>
                    </a:ext>
                  </a:extLst>
                </a:gridCol>
                <a:gridCol w="1127052">
                  <a:extLst>
                    <a:ext uri="{9D8B030D-6E8A-4147-A177-3AD203B41FA5}">
                      <a16:colId xmlns:a16="http://schemas.microsoft.com/office/drawing/2014/main" val="698794689"/>
                    </a:ext>
                  </a:extLst>
                </a:gridCol>
              </a:tblGrid>
              <a:tr h="228600">
                <a:tc rowSpan="2" gridSpan="2">
                  <a:txBody>
                    <a:bodyPr/>
                    <a:lstStyle/>
                    <a:p>
                      <a:pPr algn="ctr"/>
                      <a:r>
                        <a:rPr lang="en" altLang="zh-CN" sz="800" b="1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haracteristic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1500" b="1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eference</a:t>
                      </a:r>
                      <a:r>
                        <a:rPr lang="zh-CN" altLang="en-US" sz="800" b="1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b="1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ange</a:t>
                      </a:r>
                      <a:endParaRPr lang="zh-CN" altLang="en-US" sz="800" b="1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ult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14701628"/>
                  </a:ext>
                </a:extLst>
              </a:tr>
              <a:tr h="228600">
                <a:tc gridSpan="2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and</a:t>
                      </a:r>
                      <a:r>
                        <a:rPr lang="zh-CN" altLang="en-US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zh-CN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and</a:t>
                      </a:r>
                      <a:r>
                        <a:rPr lang="zh-CN" altLang="en-US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CN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6934910"/>
                  </a:ext>
                </a:extLst>
              </a:tr>
              <a:tr h="252000">
                <a:tc rowSpan="8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toantibody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" altLang="zh-CN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nuclear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52583785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pPr algn="ctr"/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" altLang="zh-CN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ds-DNA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4478142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pPr algn="ctr"/>
                      <a:endParaRPr lang="zh-CN" alt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" altLang="zh-CN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nucleosome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6185690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pPr algn="ctr"/>
                      <a:endParaRPr lang="zh-CN" alt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histone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0375403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pPr algn="ctr"/>
                      <a:endParaRPr lang="zh-CN" alt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</a:pPr>
                      <a:r>
                        <a:rPr lang="en" altLang="zh-CN" sz="8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nti-JO-</a:t>
                      </a:r>
                      <a:endParaRPr lang="zh-CN" altLang="en-US" sz="8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213685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pPr algn="ctr"/>
                      <a:endParaRPr lang="zh-CN" alt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</a:pPr>
                      <a:r>
                        <a:rPr lang="en" altLang="zh-CN" sz="8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nti-R0-5</a:t>
                      </a:r>
                      <a:endParaRPr lang="zh-CN" altLang="en-US" sz="8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7391210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pPr algn="ctr"/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8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nti-mitochondrial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771922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pPr algn="ctr"/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8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nti</a:t>
                      </a:r>
                      <a:r>
                        <a:rPr lang="en-US" altLang="zh-CN" sz="8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P</a:t>
                      </a:r>
                      <a:endParaRPr lang="zh-CN" altLang="en-US" sz="8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7043688"/>
                  </a:ext>
                </a:extLst>
              </a:tr>
              <a:tr h="252000">
                <a:tc row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800" b="1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ntineutrophil cytoplasmic antibody</a:t>
                      </a:r>
                      <a:endParaRPr lang="zh-CN" altLang="en-US" sz="800" b="1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eloperoxidase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4569148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pPr algn="ctr"/>
                      <a:endParaRPr lang="zh-CN" alt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8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nti-GBM</a:t>
                      </a:r>
                      <a:endParaRPr lang="zh-CN" altLang="en-US" sz="8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5217536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pPr algn="ctr"/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ase 3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6987863"/>
                  </a:ext>
                </a:extLst>
              </a:tr>
              <a:tr h="252000">
                <a:tc rowSpan="6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800" b="1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mmunity I</a:t>
                      </a:r>
                      <a:endParaRPr lang="zh-CN" altLang="en-US" sz="800" b="1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8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gA</a:t>
                      </a:r>
                      <a:endParaRPr lang="zh-CN" altLang="en-US" sz="8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-2.59</a:t>
                      </a:r>
                      <a:r>
                        <a: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82</a:t>
                      </a:r>
                      <a:r>
                        <a:rPr lang="zh-CN" alt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62</a:t>
                      </a:r>
                      <a:r>
                        <a:rPr lang="zh-CN" alt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7512397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pPr algn="ctr"/>
                      <a:endParaRPr lang="zh-CN" altLang="en-US" sz="120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8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gG</a:t>
                      </a:r>
                      <a:endParaRPr lang="zh-CN" altLang="en-US" sz="8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8-21.9</a:t>
                      </a:r>
                      <a:r>
                        <a: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.61</a:t>
                      </a:r>
                      <a:r>
                        <a:rPr lang="zh-CN" alt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.43</a:t>
                      </a:r>
                      <a:r>
                        <a:rPr lang="zh-CN" alt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2488855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pPr algn="ctr"/>
                      <a:endParaRPr lang="zh-CN" altLang="en-US" sz="120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8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gM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-2.26</a:t>
                      </a:r>
                      <a:r>
                        <a: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8</a:t>
                      </a:r>
                      <a:r>
                        <a:rPr lang="zh-CN" alt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3</a:t>
                      </a:r>
                      <a:r>
                        <a:rPr lang="zh-CN" alt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8744033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pPr algn="ctr"/>
                      <a:endParaRPr lang="zh-CN" altLang="en-US" sz="120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8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g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-165</a:t>
                      </a:r>
                      <a:r>
                        <a: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U/m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.10</a:t>
                      </a:r>
                      <a:r>
                        <a:rPr lang="zh-CN" alt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U/m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6.05</a:t>
                      </a:r>
                      <a:r>
                        <a:rPr lang="zh-CN" alt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U/m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5205252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pPr algn="ctr"/>
                      <a:endParaRPr lang="zh-CN" altLang="en-US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8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omplement C3</a:t>
                      </a:r>
                      <a:endParaRPr lang="zh-CN" altLang="en-US" sz="8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-2.06</a:t>
                      </a:r>
                      <a:r>
                        <a: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6</a:t>
                      </a:r>
                      <a:r>
                        <a:rPr lang="zh-CN" alt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0</a:t>
                      </a:r>
                      <a:r>
                        <a:rPr lang="zh-CN" alt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5865253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pPr algn="ctr"/>
                      <a:endParaRPr lang="zh-CN" altLang="en-US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8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omplement C4</a:t>
                      </a:r>
                      <a:endParaRPr lang="zh-CN" altLang="en-US" sz="8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-0.61</a:t>
                      </a:r>
                      <a:r>
                        <a: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21</a:t>
                      </a:r>
                      <a:r>
                        <a:rPr lang="zh-CN" alt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20</a:t>
                      </a:r>
                      <a:r>
                        <a:rPr lang="zh-CN" alt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L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4871254"/>
                  </a:ext>
                </a:extLst>
              </a:tr>
            </a:tbl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A97D2E81-9AA2-5B08-6BBC-ED867746BF50}"/>
              </a:ext>
            </a:extLst>
          </p:cNvPr>
          <p:cNvSpPr txBox="1"/>
          <p:nvPr/>
        </p:nvSpPr>
        <p:spPr>
          <a:xfrm>
            <a:off x="1272252" y="187765"/>
            <a:ext cx="3646936" cy="21544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kern="10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defRPr>
            </a:lvl1pPr>
          </a:lstStyle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Mutations in the </a:t>
            </a:r>
            <a:r>
              <a:rPr lang="en-US" altLang="zh-CN" sz="800" b="1" i="1" dirty="0">
                <a:latin typeface="Arial" panose="020B0604020202020204" pitchFamily="34" charset="0"/>
                <a:cs typeface="Arial" panose="020B0604020202020204" pitchFamily="34" charset="0"/>
              </a:rPr>
              <a:t>CUBN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 and their effects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ACBC147-6723-7D50-C06A-BB0DD6197DB8}"/>
              </a:ext>
            </a:extLst>
          </p:cNvPr>
          <p:cNvSpPr txBox="1"/>
          <p:nvPr/>
        </p:nvSpPr>
        <p:spPr>
          <a:xfrm>
            <a:off x="176614" y="2666149"/>
            <a:ext cx="60121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otes: GRAVY. Grand average of hydropathicity, the negative GRAVY value indicates the hydrophilic nature of the protein.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表格 6">
            <a:extLst>
              <a:ext uri="{FF2B5EF4-FFF2-40B4-BE49-F238E27FC236}">
                <a16:creationId xmlns:a16="http://schemas.microsoft.com/office/drawing/2014/main" id="{1D434EA8-81E7-7558-E489-4DD65D98064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0608887"/>
              </p:ext>
            </p:extLst>
          </p:nvPr>
        </p:nvGraphicFramePr>
        <p:xfrm>
          <a:off x="427509" y="400738"/>
          <a:ext cx="5245812" cy="225848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676539">
                  <a:extLst>
                    <a:ext uri="{9D8B030D-6E8A-4147-A177-3AD203B41FA5}">
                      <a16:colId xmlns:a16="http://schemas.microsoft.com/office/drawing/2014/main" val="2676314984"/>
                    </a:ext>
                  </a:extLst>
                </a:gridCol>
                <a:gridCol w="1059255">
                  <a:extLst>
                    <a:ext uri="{9D8B030D-6E8A-4147-A177-3AD203B41FA5}">
                      <a16:colId xmlns:a16="http://schemas.microsoft.com/office/drawing/2014/main" val="1948450875"/>
                    </a:ext>
                  </a:extLst>
                </a:gridCol>
                <a:gridCol w="778598">
                  <a:extLst>
                    <a:ext uri="{9D8B030D-6E8A-4147-A177-3AD203B41FA5}">
                      <a16:colId xmlns:a16="http://schemas.microsoft.com/office/drawing/2014/main" val="1421459250"/>
                    </a:ext>
                  </a:extLst>
                </a:gridCol>
                <a:gridCol w="826420">
                  <a:extLst>
                    <a:ext uri="{9D8B030D-6E8A-4147-A177-3AD203B41FA5}">
                      <a16:colId xmlns:a16="http://schemas.microsoft.com/office/drawing/2014/main" val="3883947370"/>
                    </a:ext>
                  </a:extLst>
                </a:gridCol>
                <a:gridCol w="740228">
                  <a:extLst>
                    <a:ext uri="{9D8B030D-6E8A-4147-A177-3AD203B41FA5}">
                      <a16:colId xmlns:a16="http://schemas.microsoft.com/office/drawing/2014/main" val="1935874706"/>
                    </a:ext>
                  </a:extLst>
                </a:gridCol>
                <a:gridCol w="1164772">
                  <a:extLst>
                    <a:ext uri="{9D8B030D-6E8A-4147-A177-3AD203B41FA5}">
                      <a16:colId xmlns:a16="http://schemas.microsoft.com/office/drawing/2014/main" val="342772695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name</a:t>
                      </a:r>
                      <a:endParaRPr lang="zh-CN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 of amino acid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ucleotide)</a:t>
                      </a:r>
                      <a:endParaRPr lang="zh-CN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ino acids</a:t>
                      </a:r>
                      <a:endParaRPr lang="zh-CN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lecular weight</a:t>
                      </a:r>
                      <a:endParaRPr lang="zh-CN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oretical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</a:t>
                      </a:r>
                      <a:endParaRPr lang="zh-CN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nd average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 hydropathicity</a:t>
                      </a:r>
                      <a:endParaRPr lang="zh-CN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8171056"/>
                  </a:ext>
                </a:extLst>
              </a:tr>
              <a:tr h="360256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:</a:t>
                      </a:r>
                      <a:r>
                        <a:rPr lang="en-US" altLang="zh-CN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BN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80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23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8736.28</a:t>
                      </a:r>
                      <a:endParaRPr lang="zh-CN" altLang="zh-CN" sz="80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4</a:t>
                      </a:r>
                      <a:endParaRPr lang="zh-CN" altLang="zh-CN" sz="80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95</a:t>
                      </a:r>
                      <a:endParaRPr lang="zh-CN" altLang="zh-CN" sz="80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0284770"/>
                  </a:ext>
                </a:extLst>
              </a:tr>
              <a:tr h="360256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:</a:t>
                      </a:r>
                      <a:r>
                        <a:rPr lang="en-US" altLang="zh-CN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BN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.4397G&gt;A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p.C1466Y) 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23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8796.31</a:t>
                      </a:r>
                      <a:endParaRPr lang="zh-CN" altLang="zh-CN" sz="80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4</a:t>
                      </a:r>
                      <a:endParaRPr lang="en-US" altLang="zh-CN" sz="80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96</a:t>
                      </a:r>
                      <a:endParaRPr lang="zh-CN" altLang="zh-CN" sz="80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8881358"/>
                  </a:ext>
                </a:extLst>
              </a:tr>
              <a:tr h="360256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:</a:t>
                      </a:r>
                      <a:r>
                        <a:rPr lang="en-US" altLang="zh-CN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BN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.6796C&gt;T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p.R2266X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66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9978.09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3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96</a:t>
                      </a:r>
                      <a:endParaRPr lang="zh-CN" altLang="zh-CN" sz="80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7762390"/>
                  </a:ext>
                </a:extLst>
              </a:tr>
              <a:tr h="360256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3:</a:t>
                      </a:r>
                      <a:r>
                        <a:rPr lang="en-US" altLang="zh-CN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BN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5153_5154delCT</a:t>
                      </a:r>
                    </a:p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p.S1718X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17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0057.60</a:t>
                      </a:r>
                      <a:endParaRPr lang="zh-CN" altLang="zh-CN" sz="80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2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17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4618935"/>
                  </a:ext>
                </a:extLst>
              </a:tr>
              <a:tr h="3602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4:</a:t>
                      </a:r>
                      <a:r>
                        <a:rPr lang="en-US" altLang="zh-CN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BN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6821+3A&gt;G</a:t>
                      </a:r>
                    </a:p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splicing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55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8822.18</a:t>
                      </a:r>
                      <a:endParaRPr lang="zh-CN" altLang="zh-CN" sz="80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5</a:t>
                      </a:r>
                      <a:endParaRPr lang="zh-CN" altLang="zh-CN" sz="80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80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70101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025659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71</TotalTime>
  <Words>274</Words>
  <Application>Microsoft Macintosh PowerPoint</Application>
  <PresentationFormat>自定义</PresentationFormat>
  <Paragraphs>12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ainve borry</dc:creator>
  <cp:lastModifiedBy>jainve borry</cp:lastModifiedBy>
  <cp:revision>562</cp:revision>
  <cp:lastPrinted>2021-10-26T08:02:00Z</cp:lastPrinted>
  <dcterms:created xsi:type="dcterms:W3CDTF">2021-05-03T12:59:33Z</dcterms:created>
  <dcterms:modified xsi:type="dcterms:W3CDTF">2022-09-23T11:00:42Z</dcterms:modified>
</cp:coreProperties>
</file>